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97CEE75-7FEE-4F05-8F39-0974584F65A8}" v="1" dt="2020-05-10T15:32:19.26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2550" y="6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homas Duguet" userId="a91692563c359211" providerId="LiveId" clId="{D97CEE75-7FEE-4F05-8F39-0974584F65A8}"/>
    <pc:docChg chg="addSld delSld modSld">
      <pc:chgData name="Thomas Duguet" userId="a91692563c359211" providerId="LiveId" clId="{D97CEE75-7FEE-4F05-8F39-0974584F65A8}" dt="2020-05-10T15:32:21.145" v="1" actId="2696"/>
      <pc:docMkLst>
        <pc:docMk/>
      </pc:docMkLst>
      <pc:sldChg chg="del">
        <pc:chgData name="Thomas Duguet" userId="a91692563c359211" providerId="LiveId" clId="{D97CEE75-7FEE-4F05-8F39-0974584F65A8}" dt="2020-05-10T15:32:21.145" v="1" actId="2696"/>
        <pc:sldMkLst>
          <pc:docMk/>
          <pc:sldMk cId="4126939010" sldId="257"/>
        </pc:sldMkLst>
      </pc:sldChg>
      <pc:sldChg chg="add">
        <pc:chgData name="Thomas Duguet" userId="a91692563c359211" providerId="LiveId" clId="{D97CEE75-7FEE-4F05-8F39-0974584F65A8}" dt="2020-05-10T15:32:19.262" v="0"/>
        <pc:sldMkLst>
          <pc:docMk/>
          <pc:sldMk cId="3563917273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11697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5793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1237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9968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92445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6717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6297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88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0073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7792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74364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90AA4-C43A-4DAF-A6A9-7CAFF185B98D}" type="datetimeFigureOut">
              <a:rPr lang="en-CA" smtClean="0"/>
              <a:t>2020-05-1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D26897-1EAE-4C6A-A688-0EE578A60806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1794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C111598B-385D-4585-81A4-4FED1B8977D0}"/>
              </a:ext>
            </a:extLst>
          </p:cNvPr>
          <p:cNvGrpSpPr/>
          <p:nvPr/>
        </p:nvGrpSpPr>
        <p:grpSpPr>
          <a:xfrm>
            <a:off x="4007035" y="2627478"/>
            <a:ext cx="771494" cy="4400548"/>
            <a:chOff x="1275348" y="1630279"/>
            <a:chExt cx="962528" cy="588344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2A3A32A6-457B-4EFD-80DB-395878A54E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2001" t="5679" r="74018" b="4764"/>
            <a:stretch/>
          </p:blipFill>
          <p:spPr>
            <a:xfrm>
              <a:off x="1275348" y="1630279"/>
              <a:ext cx="938464" cy="588344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69E1468-C325-47FC-BCD3-9214B88286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l="74018" t="5679" r="12001" b="4764"/>
            <a:stretch/>
          </p:blipFill>
          <p:spPr>
            <a:xfrm>
              <a:off x="1299414" y="1630279"/>
              <a:ext cx="938462" cy="5883442"/>
            </a:xfrm>
            <a:prstGeom prst="rect">
              <a:avLst/>
            </a:prstGeom>
          </p:spPr>
        </p:pic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71E927D9-E90C-4067-B44F-AB687160E44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34345" t="9635" r="61205"/>
          <a:stretch/>
        </p:blipFill>
        <p:spPr>
          <a:xfrm>
            <a:off x="4871367" y="5038033"/>
            <a:ext cx="209748" cy="205961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130EFD7-8505-49E4-83E1-8ACF026FADDD}"/>
              </a:ext>
            </a:extLst>
          </p:cNvPr>
          <p:cNvSpPr txBox="1"/>
          <p:nvPr/>
        </p:nvSpPr>
        <p:spPr>
          <a:xfrm>
            <a:off x="5004976" y="5326417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2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F854E0-8C41-4DFF-89B5-38535F681783}"/>
              </a:ext>
            </a:extLst>
          </p:cNvPr>
          <p:cNvSpPr txBox="1"/>
          <p:nvPr/>
        </p:nvSpPr>
        <p:spPr>
          <a:xfrm>
            <a:off x="5009432" y="5717616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4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0028625-59DC-4A9D-BD7C-2B7C5C92A2A3}"/>
              </a:ext>
            </a:extLst>
          </p:cNvPr>
          <p:cNvSpPr txBox="1"/>
          <p:nvPr/>
        </p:nvSpPr>
        <p:spPr>
          <a:xfrm>
            <a:off x="5004976" y="6106711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6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6A00540-4CE6-4B7E-8F06-10787FFFF98E}"/>
              </a:ext>
            </a:extLst>
          </p:cNvPr>
          <p:cNvSpPr txBox="1"/>
          <p:nvPr/>
        </p:nvSpPr>
        <p:spPr>
          <a:xfrm>
            <a:off x="4997336" y="6500015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0.8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701D449-6B48-4D64-A46F-8FF947F690D9}"/>
              </a:ext>
            </a:extLst>
          </p:cNvPr>
          <p:cNvSpPr txBox="1"/>
          <p:nvPr/>
        </p:nvSpPr>
        <p:spPr>
          <a:xfrm>
            <a:off x="5017815" y="6888163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BD1BBE6-7A76-403E-8452-7DB44A8A80D4}"/>
              </a:ext>
            </a:extLst>
          </p:cNvPr>
          <p:cNvSpPr txBox="1"/>
          <p:nvPr/>
        </p:nvSpPr>
        <p:spPr>
          <a:xfrm rot="5400000">
            <a:off x="2719503" y="4787068"/>
            <a:ext cx="54453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motility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fractional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difference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A" sz="800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fr-CA" sz="800" dirty="0">
                <a:latin typeface="Arial" panose="020B0604020202020204" pitchFamily="34" charset="0"/>
                <a:cs typeface="Arial" panose="020B0604020202020204" pitchFamily="34" charset="0"/>
              </a:rPr>
              <a:t> to control)</a:t>
            </a:r>
            <a:endParaRPr lang="en-CA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D8132CB-B0C3-4789-BEA3-C5568EA378D9}"/>
              </a:ext>
            </a:extLst>
          </p:cNvPr>
          <p:cNvSpPr txBox="1"/>
          <p:nvPr/>
        </p:nvSpPr>
        <p:spPr>
          <a:xfrm>
            <a:off x="4750376" y="4705738"/>
            <a:ext cx="470313" cy="277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fr-CA" sz="601" dirty="0" err="1">
                <a:latin typeface="Arial" panose="020B0604020202020204" pitchFamily="34" charset="0"/>
                <a:cs typeface="Arial" panose="020B0604020202020204" pitchFamily="34" charset="0"/>
              </a:rPr>
              <a:t>motility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2F75035-2337-4949-9036-50877B7675D3}"/>
              </a:ext>
            </a:extLst>
          </p:cNvPr>
          <p:cNvSpPr txBox="1"/>
          <p:nvPr/>
        </p:nvSpPr>
        <p:spPr>
          <a:xfrm rot="10800000">
            <a:off x="4997337" y="4751968"/>
            <a:ext cx="336648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8F526BB-E065-41D9-8C41-7356C87412CE}"/>
              </a:ext>
            </a:extLst>
          </p:cNvPr>
          <p:cNvSpPr txBox="1"/>
          <p:nvPr/>
        </p:nvSpPr>
        <p:spPr>
          <a:xfrm>
            <a:off x="4759241" y="7033902"/>
            <a:ext cx="7049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700" dirty="0" err="1">
                <a:latin typeface="Arial" panose="020B0604020202020204" pitchFamily="34" charset="0"/>
                <a:cs typeface="Arial" panose="020B0604020202020204" pitchFamily="34" charset="0"/>
              </a:rPr>
              <a:t>hypomotility</a:t>
            </a:r>
            <a:endParaRPr lang="en-CA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CCC990C-C0A1-4CBF-B642-FE1152C76FAC}"/>
              </a:ext>
            </a:extLst>
          </p:cNvPr>
          <p:cNvSpPr txBox="1"/>
          <p:nvPr/>
        </p:nvSpPr>
        <p:spPr>
          <a:xfrm>
            <a:off x="4750376" y="2420695"/>
            <a:ext cx="10185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700" dirty="0" err="1">
                <a:latin typeface="Arial" panose="020B0604020202020204" pitchFamily="34" charset="0"/>
                <a:cs typeface="Arial" panose="020B0604020202020204" pitchFamily="34" charset="0"/>
              </a:rPr>
              <a:t>hypermotility</a:t>
            </a:r>
            <a:endParaRPr lang="en-CA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9934B6C7-7234-47F9-9B9F-2EB3CB8C219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8720" t="7689" r="6381"/>
          <a:stretch/>
        </p:blipFill>
        <p:spPr>
          <a:xfrm rot="10800000">
            <a:off x="4834504" y="2536734"/>
            <a:ext cx="274320" cy="2134476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BDEFDCE-1E23-4240-AEF5-818578225113}"/>
              </a:ext>
            </a:extLst>
          </p:cNvPr>
          <p:cNvSpPr txBox="1"/>
          <p:nvPr/>
        </p:nvSpPr>
        <p:spPr>
          <a:xfrm>
            <a:off x="5004976" y="2573810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BECAFAC-A23A-4DF0-B1B6-A8FDA479F892}"/>
              </a:ext>
            </a:extLst>
          </p:cNvPr>
          <p:cNvSpPr txBox="1"/>
          <p:nvPr/>
        </p:nvSpPr>
        <p:spPr>
          <a:xfrm>
            <a:off x="5001151" y="3378511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FAFD14F-6197-4EE2-A46A-1CC6109E1FC3}"/>
              </a:ext>
            </a:extLst>
          </p:cNvPr>
          <p:cNvSpPr txBox="1"/>
          <p:nvPr/>
        </p:nvSpPr>
        <p:spPr>
          <a:xfrm>
            <a:off x="4998497" y="2978223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B44AD44-514D-45CB-A0BC-9C1C8AD23B02}"/>
              </a:ext>
            </a:extLst>
          </p:cNvPr>
          <p:cNvSpPr txBox="1"/>
          <p:nvPr/>
        </p:nvSpPr>
        <p:spPr>
          <a:xfrm>
            <a:off x="5004977" y="3789762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45A3542-2ADD-4B03-9F69-D22F09B07CE6}"/>
              </a:ext>
            </a:extLst>
          </p:cNvPr>
          <p:cNvSpPr txBox="1"/>
          <p:nvPr/>
        </p:nvSpPr>
        <p:spPr>
          <a:xfrm>
            <a:off x="4999658" y="4200283"/>
            <a:ext cx="1213883" cy="1847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CA" sz="6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8E9D58-5315-4BC4-8A60-8810244E7533}"/>
              </a:ext>
            </a:extLst>
          </p:cNvPr>
          <p:cNvSpPr txBox="1"/>
          <p:nvPr/>
        </p:nvSpPr>
        <p:spPr>
          <a:xfrm rot="18289869">
            <a:off x="3797627" y="1942681"/>
            <a:ext cx="15114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1 ; 10 </a:t>
            </a:r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F3CEA33-CBDF-4F56-8208-E57FC486AADE}"/>
              </a:ext>
            </a:extLst>
          </p:cNvPr>
          <p:cNvSpPr txBox="1"/>
          <p:nvPr/>
        </p:nvSpPr>
        <p:spPr>
          <a:xfrm rot="18289869">
            <a:off x="4135864" y="1921802"/>
            <a:ext cx="15114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fr-CA" sz="600" b="1" dirty="0">
                <a:latin typeface="Arial" panose="020B0604020202020204" pitchFamily="34" charset="0"/>
                <a:cs typeface="Arial" panose="020B0604020202020204" pitchFamily="34" charset="0"/>
              </a:rPr>
              <a:t> 5 ; 10 </a:t>
            </a:r>
            <a:r>
              <a:rPr lang="fr-CA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endParaRPr lang="en-CA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Table 26">
            <a:extLst>
              <a:ext uri="{FF2B5EF4-FFF2-40B4-BE49-F238E27FC236}">
                <a16:creationId xmlns:a16="http://schemas.microsoft.com/office/drawing/2014/main" id="{D61987B4-34DA-4368-98A7-5D3CBF513696}"/>
              </a:ext>
            </a:extLst>
          </p:cNvPr>
          <p:cNvGraphicFramePr>
            <a:graphicFrameLocks noGrp="1"/>
          </p:cNvGraphicFramePr>
          <p:nvPr/>
        </p:nvGraphicFramePr>
        <p:xfrm>
          <a:off x="4025225" y="2666207"/>
          <a:ext cx="705356" cy="434277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52678">
                  <a:extLst>
                    <a:ext uri="{9D8B030D-6E8A-4147-A177-3AD203B41FA5}">
                      <a16:colId xmlns:a16="http://schemas.microsoft.com/office/drawing/2014/main" val="2129196659"/>
                    </a:ext>
                  </a:extLst>
                </a:gridCol>
                <a:gridCol w="352678">
                  <a:extLst>
                    <a:ext uri="{9D8B030D-6E8A-4147-A177-3AD203B41FA5}">
                      <a16:colId xmlns:a16="http://schemas.microsoft.com/office/drawing/2014/main" val="1727627487"/>
                    </a:ext>
                  </a:extLst>
                </a:gridCol>
              </a:tblGrid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28476069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97197785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44099892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99717608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25366198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67509900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42119427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6722224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238829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56999982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75535195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48745850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12611547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6349439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17672840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17946292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7588043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50589529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73711374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5220361"/>
                  </a:ext>
                </a:extLst>
              </a:tr>
              <a:tr h="206799"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CA" sz="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●●●</a:t>
                      </a:r>
                      <a:endParaRPr lang="en-CA" sz="6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44564859"/>
                  </a:ext>
                </a:extLst>
              </a:tr>
            </a:tbl>
          </a:graphicData>
        </a:graphic>
      </p:graphicFrame>
      <p:graphicFrame>
        <p:nvGraphicFramePr>
          <p:cNvPr id="28" name="Table 27">
            <a:extLst>
              <a:ext uri="{FF2B5EF4-FFF2-40B4-BE49-F238E27FC236}">
                <a16:creationId xmlns:a16="http://schemas.microsoft.com/office/drawing/2014/main" id="{3A5C6F2C-8890-44AB-B72C-98CAC8B89D39}"/>
              </a:ext>
            </a:extLst>
          </p:cNvPr>
          <p:cNvGraphicFramePr>
            <a:graphicFrameLocks noGrp="1"/>
          </p:cNvGraphicFramePr>
          <p:nvPr/>
        </p:nvGraphicFramePr>
        <p:xfrm>
          <a:off x="599511" y="2420694"/>
          <a:ext cx="3309548" cy="458829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27387">
                  <a:extLst>
                    <a:ext uri="{9D8B030D-6E8A-4147-A177-3AD203B41FA5}">
                      <a16:colId xmlns:a16="http://schemas.microsoft.com/office/drawing/2014/main" val="2129196659"/>
                    </a:ext>
                  </a:extLst>
                </a:gridCol>
                <a:gridCol w="827387">
                  <a:extLst>
                    <a:ext uri="{9D8B030D-6E8A-4147-A177-3AD203B41FA5}">
                      <a16:colId xmlns:a16="http://schemas.microsoft.com/office/drawing/2014/main" val="2487891736"/>
                    </a:ext>
                  </a:extLst>
                </a:gridCol>
                <a:gridCol w="827387">
                  <a:extLst>
                    <a:ext uri="{9D8B030D-6E8A-4147-A177-3AD203B41FA5}">
                      <a16:colId xmlns:a16="http://schemas.microsoft.com/office/drawing/2014/main" val="3688913920"/>
                    </a:ext>
                  </a:extLst>
                </a:gridCol>
                <a:gridCol w="827387">
                  <a:extLst>
                    <a:ext uri="{9D8B030D-6E8A-4147-A177-3AD203B41FA5}">
                      <a16:colId xmlns:a16="http://schemas.microsoft.com/office/drawing/2014/main" val="1252417169"/>
                    </a:ext>
                  </a:extLst>
                </a:gridCol>
              </a:tblGrid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2 phenotype</a:t>
                      </a:r>
                      <a:endParaRPr lang="en-CA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5 </a:t>
                      </a:r>
                      <a:r>
                        <a:rPr lang="fr-CA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enotype</a:t>
                      </a:r>
                      <a:endParaRPr lang="en-CA" sz="8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en-CA" sz="800" b="1" u="none" strike="noStrike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iability (%) - d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67447371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PS-2143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motile</a:t>
                      </a:r>
                      <a:endParaRPr lang="en-CA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CA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CA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28476069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97197785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44099892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motil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lyzed, dark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99717608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25366198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67509900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42119427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6722224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238829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56999982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75535195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48745850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81848066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nulate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32762298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rk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63004788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81227688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71935013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  <a:endParaRPr lang="en-CA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CA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72909456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CA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CA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12261049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71116162"/>
                  </a:ext>
                </a:extLst>
              </a:tr>
              <a:tr h="208559">
                <a:tc>
                  <a:txBody>
                    <a:bodyPr/>
                    <a:lstStyle/>
                    <a:p>
                      <a:pPr marL="0" marR="0" lvl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CA" sz="800" b="1" i="0" u="none" strike="noStrike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ermotile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rk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39076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63917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5</Words>
  <Application>Microsoft Office PowerPoint</Application>
  <PresentationFormat>On-screen Show (4:3)</PresentationFormat>
  <Paragraphs>1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Duguet</dc:creator>
  <cp:lastModifiedBy>Thomas Duguet</cp:lastModifiedBy>
  <cp:revision>1</cp:revision>
  <dcterms:created xsi:type="dcterms:W3CDTF">2020-05-10T15:30:36Z</dcterms:created>
  <dcterms:modified xsi:type="dcterms:W3CDTF">2020-05-10T15:32:24Z</dcterms:modified>
</cp:coreProperties>
</file>